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74"/>
  </p:normalViewPr>
  <p:slideViewPr>
    <p:cSldViewPr snapToGrid="0" snapToObjects="1">
      <p:cViewPr varScale="1">
        <p:scale>
          <a:sx n="131" d="100"/>
          <a:sy n="131" d="100"/>
        </p:scale>
        <p:origin x="3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CCBAAB6-E333-BA4A-93CB-2084B751229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D784D3EB-48C4-7D49-B819-8EDCE49585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3C9F124-3867-E147-91BD-8318465490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F1401-D9C0-7645-A694-63DB52302318}" type="datetimeFigureOut">
              <a:rPr lang="fr-FR" smtClean="0"/>
              <a:t>25/06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9E915B9-1C74-4A41-A490-83C6291131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AFA815B-EED6-AA40-8B68-9029E5FED2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C1DB9-87B5-5042-9B3A-B9D6CCDA7F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64496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E27324A-3653-CF4E-B607-E952B38C32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606BDCE1-6C51-8F41-9794-D0E3C36BD9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F3480C0-82B4-4C47-8F23-3F2DCA820C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F1401-D9C0-7645-A694-63DB52302318}" type="datetimeFigureOut">
              <a:rPr lang="fr-FR" smtClean="0"/>
              <a:t>25/06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1B192C0-7B9F-4141-8AEC-2DF85BEC1A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5E602CC-8C0F-8B41-B497-4394F29966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C1DB9-87B5-5042-9B3A-B9D6CCDA7F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371698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424A2FF8-0D50-B147-A4B3-57F2C1F8D9F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F4551ADA-0792-F94F-917B-5BBDA8C84E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F94B346-0C9C-E342-98F8-37F816331F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F1401-D9C0-7645-A694-63DB52302318}" type="datetimeFigureOut">
              <a:rPr lang="fr-FR" smtClean="0"/>
              <a:t>25/06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AD396EC-2370-194C-9FEA-92878515BC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5F7C4A8-5312-574B-8D33-337F5F3FF2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C1DB9-87B5-5042-9B3A-B9D6CCDA7F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69529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2D8AA33-7D6A-C241-A94C-E3BC4F76B9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683C9649-746C-D542-B5B8-7960401FFF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B43EB4B-766E-7F49-9D81-2B5D581570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F1401-D9C0-7645-A694-63DB52302318}" type="datetimeFigureOut">
              <a:rPr lang="fr-FR" smtClean="0"/>
              <a:t>25/06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F43680F-BAE1-824C-8286-CCEF53D841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F2A241B-2F72-864F-AE4B-CC470B44EF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C1DB9-87B5-5042-9B3A-B9D6CCDA7F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1257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EC2249B-46DB-374E-B2F0-149F7E9587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50D2C01-87EA-0847-A74A-78525CE7E1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3FD56E5-7C55-9444-BA86-C7553F153C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F1401-D9C0-7645-A694-63DB52302318}" type="datetimeFigureOut">
              <a:rPr lang="fr-FR" smtClean="0"/>
              <a:t>25/06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8254193-12B5-394C-BD19-8D58FC194D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C2257AC-EE8A-844B-8870-A0E2C31572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C1DB9-87B5-5042-9B3A-B9D6CCDA7F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40623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9A2F695-4AB6-B944-AB59-B405A89C8C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EE36DAA-542B-C34F-880C-B524F7D5C7D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FE0048A5-49D2-3C4D-912F-56C9B30E21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D157784-A449-DC46-ABF7-DBE2C520DE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F1401-D9C0-7645-A694-63DB52302318}" type="datetimeFigureOut">
              <a:rPr lang="fr-FR" smtClean="0"/>
              <a:t>25/06/2019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C5AA1AF-A3F0-F646-A878-8BBCA5E70D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07A9E52-42CC-8147-89B1-23E44C18FE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C1DB9-87B5-5042-9B3A-B9D6CCDA7F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78531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3372171-6221-2D43-B653-0DCCF853D9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C48A3F9-FA5C-284E-82C8-9520BAAF0B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BF3EBFC0-A2DB-B64D-8A3B-4E47CBE8EF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B2AF2426-99C2-CA41-8155-3340E0793DA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AFACB738-6B84-DB4D-823C-37E8BA7A964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39803BA4-4D1A-5B4C-ABE6-1825695AF1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F1401-D9C0-7645-A694-63DB52302318}" type="datetimeFigureOut">
              <a:rPr lang="fr-FR" smtClean="0"/>
              <a:t>25/06/2019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25F5C75C-4159-C44A-AEC3-8D6556E7F3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3D6B925F-D0CB-F442-836C-5E60776FEB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C1DB9-87B5-5042-9B3A-B9D6CCDA7F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03260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6A460C1-2DBE-4E43-BCE8-FC8EA97BDF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60815174-E5A9-5248-BA6A-1F19FFA307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F1401-D9C0-7645-A694-63DB52302318}" type="datetimeFigureOut">
              <a:rPr lang="fr-FR" smtClean="0"/>
              <a:t>25/06/2019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7C1B47F6-4DC3-4344-9749-A768F15379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8BF0363A-CC7A-5241-9CBF-797D6101E4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C1DB9-87B5-5042-9B3A-B9D6CCDA7F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5938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3255CA5D-1071-1640-992F-61EE4BA1B5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F1401-D9C0-7645-A694-63DB52302318}" type="datetimeFigureOut">
              <a:rPr lang="fr-FR" smtClean="0"/>
              <a:t>25/06/2019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BDA7FF96-9088-5B43-99A0-95B36F5B1F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7BFB0672-1283-B144-B868-AA3F429E04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C1DB9-87B5-5042-9B3A-B9D6CCDA7F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304519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88E36C2-4C86-6B46-8F15-3FE3AB27BB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A3A7BC9-D494-9145-8FF3-B56961EF06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4AB844F-1E1E-0543-8DA1-A82302D868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2E1C227-6D1D-5D42-AC40-8F84FDA6E1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F1401-D9C0-7645-A694-63DB52302318}" type="datetimeFigureOut">
              <a:rPr lang="fr-FR" smtClean="0"/>
              <a:t>25/06/2019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BDFD49D-B4FF-AC4E-9657-7136E64708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CC282C3-CEC7-9649-AC1A-5D69CE4421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C1DB9-87B5-5042-9B3A-B9D6CCDA7F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0866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FFC6535-15CC-9143-B75D-A4BA8179F4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07BD3F16-213B-1145-8039-1D603A89320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25530762-49FD-DA4E-9861-0F6B0D69A4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BF8376C-91B0-D546-8178-BDE9FF1A5F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F1401-D9C0-7645-A694-63DB52302318}" type="datetimeFigureOut">
              <a:rPr lang="fr-FR" smtClean="0"/>
              <a:t>25/06/2019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DB16834-1303-1D41-AC2B-934FED38FF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508E46E-7600-2148-9F2A-573EDBE4E4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C1DB9-87B5-5042-9B3A-B9D6CCDA7F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88532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6F976B7F-A4C3-0C43-B8AD-C235E031C7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CB9A815-AE85-954D-AA03-C57123C326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71E789E-CF1B-D84E-9FD3-91BAC19C0DD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AF1401-D9C0-7645-A694-63DB52302318}" type="datetimeFigureOut">
              <a:rPr lang="fr-FR" smtClean="0"/>
              <a:t>25/06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C272CF9-3708-AD4E-88A9-BD80CA11036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2665FAD-05A4-D043-91CA-13DC0CAAA66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FC1DB9-87B5-5042-9B3A-B9D6CCDA7F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96193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 5">
            <a:extLst>
              <a:ext uri="{FF2B5EF4-FFF2-40B4-BE49-F238E27FC236}">
                <a16:creationId xmlns:a16="http://schemas.microsoft.com/office/drawing/2014/main" id="{655003D0-A642-1443-AFEC-5014528DEC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7089" y="1813223"/>
            <a:ext cx="7451388" cy="1655864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883CC46C-7C2D-644D-AEDA-35383219FBF9}"/>
              </a:ext>
            </a:extLst>
          </p:cNvPr>
          <p:cNvSpPr/>
          <p:nvPr/>
        </p:nvSpPr>
        <p:spPr>
          <a:xfrm>
            <a:off x="1812154" y="4004050"/>
            <a:ext cx="862562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GB" sz="1000" b="1" dirty="0">
                <a:latin typeface="Times" pitchFamily="2" charset="0"/>
                <a:ea typeface="Times New Roman" panose="02020603050405020304" pitchFamily="18" charset="0"/>
              </a:rPr>
              <a:t>S4 Fig. Localisation of the shRNA-targeted sites on </a:t>
            </a:r>
            <a:r>
              <a:rPr lang="en-GB" sz="1000" b="1" i="1" dirty="0">
                <a:latin typeface="Times" pitchFamily="2" charset="0"/>
                <a:ea typeface="Times New Roman" panose="02020603050405020304" pitchFamily="18" charset="0"/>
              </a:rPr>
              <a:t>MPV17</a:t>
            </a:r>
            <a:r>
              <a:rPr lang="en-GB" sz="1000" b="1" dirty="0">
                <a:latin typeface="Times" pitchFamily="2" charset="0"/>
                <a:ea typeface="Times New Roman" panose="02020603050405020304" pitchFamily="18" charset="0"/>
              </a:rPr>
              <a:t> transcript. </a:t>
            </a:r>
            <a:r>
              <a:rPr lang="en-GB" sz="1000" dirty="0">
                <a:latin typeface="Times" pitchFamily="2" charset="0"/>
                <a:ea typeface="Times New Roman" panose="02020603050405020304" pitchFamily="18" charset="0"/>
              </a:rPr>
              <a:t>The effects of several commercially available shRNAs directed against </a:t>
            </a:r>
            <a:r>
              <a:rPr lang="en-GB" sz="1000" i="1" dirty="0">
                <a:latin typeface="Times" pitchFamily="2" charset="0"/>
                <a:ea typeface="Times New Roman" panose="02020603050405020304" pitchFamily="18" charset="0"/>
              </a:rPr>
              <a:t>MPV17</a:t>
            </a:r>
            <a:r>
              <a:rPr lang="en-GB" sz="1000" dirty="0">
                <a:latin typeface="Times" pitchFamily="2" charset="0"/>
                <a:ea typeface="Times New Roman" panose="02020603050405020304" pitchFamily="18" charset="0"/>
              </a:rPr>
              <a:t> transcript were assessed in Huh7 cells. Each shRNA Sigma Aldrich reference (sh128669, sh131201, sh131038, sh127649 and sh129921) is indicated above its target site. Each grey box represents an exon of </a:t>
            </a:r>
            <a:r>
              <a:rPr lang="en-GB" sz="1000" i="1" dirty="0">
                <a:latin typeface="Times" pitchFamily="2" charset="0"/>
                <a:ea typeface="Times New Roman" panose="02020603050405020304" pitchFamily="18" charset="0"/>
              </a:rPr>
              <a:t>MPV17</a:t>
            </a:r>
            <a:r>
              <a:rPr lang="en-GB" sz="1000" dirty="0">
                <a:latin typeface="Times" pitchFamily="2" charset="0"/>
                <a:ea typeface="Times New Roman" panose="02020603050405020304" pitchFamily="18" charset="0"/>
              </a:rPr>
              <a:t> transcript (NM002437.5). A line indicates the 3’UTR and 5’UTR of </a:t>
            </a:r>
            <a:r>
              <a:rPr lang="en-GB" sz="1000" i="1" dirty="0">
                <a:latin typeface="Times" pitchFamily="2" charset="0"/>
                <a:ea typeface="Times New Roman" panose="02020603050405020304" pitchFamily="18" charset="0"/>
              </a:rPr>
              <a:t>MPV17</a:t>
            </a:r>
            <a:r>
              <a:rPr lang="en-GB" sz="1000" dirty="0">
                <a:latin typeface="Times" pitchFamily="2" charset="0"/>
                <a:ea typeface="Times New Roman" panose="02020603050405020304" pitchFamily="18" charset="0"/>
              </a:rPr>
              <a:t> transcript.</a:t>
            </a:r>
            <a:endParaRPr lang="fr-BE" sz="1000" dirty="0">
              <a:effectLst/>
              <a:latin typeface="Times" pitchFamily="2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585828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75</Words>
  <Application>Microsoft Macintosh PowerPoint</Application>
  <PresentationFormat>Grand écran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Microsoft Office User</cp:lastModifiedBy>
  <cp:revision>7</cp:revision>
  <cp:lastPrinted>2019-06-25T11:59:18Z</cp:lastPrinted>
  <dcterms:created xsi:type="dcterms:W3CDTF">2019-03-06T15:17:15Z</dcterms:created>
  <dcterms:modified xsi:type="dcterms:W3CDTF">2019-06-25T11:59:21Z</dcterms:modified>
</cp:coreProperties>
</file>